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9D755A0-B6BE-4298-A8F1-8524C25053C3}" v="6" dt="2024-04-15T09:23:07.62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22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ordon Fuller" userId="12b4f67a74d88020" providerId="LiveId" clId="{89D755A0-B6BE-4298-A8F1-8524C25053C3}"/>
    <pc:docChg chg="custSel addSld modSld">
      <pc:chgData name="Gordon Fuller" userId="12b4f67a74d88020" providerId="LiveId" clId="{89D755A0-B6BE-4298-A8F1-8524C25053C3}" dt="2024-04-15T09:23:46.037" v="49" actId="255"/>
      <pc:docMkLst>
        <pc:docMk/>
      </pc:docMkLst>
      <pc:sldChg chg="delSp modSp mod">
        <pc:chgData name="Gordon Fuller" userId="12b4f67a74d88020" providerId="LiveId" clId="{89D755A0-B6BE-4298-A8F1-8524C25053C3}" dt="2024-04-15T09:23:46.037" v="49" actId="255"/>
        <pc:sldMkLst>
          <pc:docMk/>
          <pc:sldMk cId="1697241378" sldId="256"/>
        </pc:sldMkLst>
        <pc:spChg chg="mod">
          <ac:chgData name="Gordon Fuller" userId="12b4f67a74d88020" providerId="LiveId" clId="{89D755A0-B6BE-4298-A8F1-8524C25053C3}" dt="2024-04-15T09:23:46.037" v="49" actId="255"/>
          <ac:spMkLst>
            <pc:docMk/>
            <pc:sldMk cId="1697241378" sldId="256"/>
            <ac:spMk id="12" creationId="{86C1C3C1-A9EA-9213-D59B-E0156A601036}"/>
          </ac:spMkLst>
        </pc:spChg>
        <pc:spChg chg="del">
          <ac:chgData name="Gordon Fuller" userId="12b4f67a74d88020" providerId="LiveId" clId="{89D755A0-B6BE-4298-A8F1-8524C25053C3}" dt="2024-04-15T09:23:18.349" v="43" actId="478"/>
          <ac:spMkLst>
            <pc:docMk/>
            <pc:sldMk cId="1697241378" sldId="256"/>
            <ac:spMk id="13" creationId="{E9727FD8-0233-8F49-5740-AE60C08B7823}"/>
          </ac:spMkLst>
        </pc:spChg>
        <pc:spChg chg="del">
          <ac:chgData name="Gordon Fuller" userId="12b4f67a74d88020" providerId="LiveId" clId="{89D755A0-B6BE-4298-A8F1-8524C25053C3}" dt="2024-04-15T09:22:10.295" v="14" actId="21"/>
          <ac:spMkLst>
            <pc:docMk/>
            <pc:sldMk cId="1697241378" sldId="256"/>
            <ac:spMk id="14" creationId="{97759BFF-F6AE-3BC4-D8E2-1249AFD1BE3D}"/>
          </ac:spMkLst>
        </pc:spChg>
        <pc:spChg chg="del mod">
          <ac:chgData name="Gordon Fuller" userId="12b4f67a74d88020" providerId="LiveId" clId="{89D755A0-B6BE-4298-A8F1-8524C25053C3}" dt="2024-04-15T09:23:04.042" v="38" actId="21"/>
          <ac:spMkLst>
            <pc:docMk/>
            <pc:sldMk cId="1697241378" sldId="256"/>
            <ac:spMk id="15" creationId="{D9D105C4-A43D-C449-30A9-1AAC6C95BB53}"/>
          </ac:spMkLst>
        </pc:spChg>
        <pc:picChg chg="mod">
          <ac:chgData name="Gordon Fuller" userId="12b4f67a74d88020" providerId="LiveId" clId="{89D755A0-B6BE-4298-A8F1-8524C25053C3}" dt="2024-04-15T09:23:42.006" v="47" actId="14100"/>
          <ac:picMkLst>
            <pc:docMk/>
            <pc:sldMk cId="1697241378" sldId="256"/>
            <ac:picMk id="5" creationId="{F3529407-8DA6-0AC9-A7E9-D5A80A835E06}"/>
          </ac:picMkLst>
        </pc:picChg>
        <pc:picChg chg="del">
          <ac:chgData name="Gordon Fuller" userId="12b4f67a74d88020" providerId="LiveId" clId="{89D755A0-B6BE-4298-A8F1-8524C25053C3}" dt="2024-04-15T09:22:44.999" v="29" actId="21"/>
          <ac:picMkLst>
            <pc:docMk/>
            <pc:sldMk cId="1697241378" sldId="256"/>
            <ac:picMk id="7" creationId="{3161FD39-83CD-8093-3C8C-54EB941F6834}"/>
          </ac:picMkLst>
        </pc:picChg>
        <pc:picChg chg="del">
          <ac:chgData name="Gordon Fuller" userId="12b4f67a74d88020" providerId="LiveId" clId="{89D755A0-B6BE-4298-A8F1-8524C25053C3}" dt="2024-04-15T09:21:48.619" v="3" actId="21"/>
          <ac:picMkLst>
            <pc:docMk/>
            <pc:sldMk cId="1697241378" sldId="256"/>
            <ac:picMk id="9" creationId="{6C409374-AF78-1CFC-52B2-72836AACE620}"/>
          </ac:picMkLst>
        </pc:picChg>
        <pc:picChg chg="del">
          <ac:chgData name="Gordon Fuller" userId="12b4f67a74d88020" providerId="LiveId" clId="{89D755A0-B6BE-4298-A8F1-8524C25053C3}" dt="2024-04-15T09:21:58.087" v="8" actId="21"/>
          <ac:picMkLst>
            <pc:docMk/>
            <pc:sldMk cId="1697241378" sldId="256"/>
            <ac:picMk id="11" creationId="{C5F040CD-D587-1AFD-9BD0-73E6212DD56C}"/>
          </ac:picMkLst>
        </pc:picChg>
      </pc:sldChg>
      <pc:sldChg chg="addSp modSp new mod">
        <pc:chgData name="Gordon Fuller" userId="12b4f67a74d88020" providerId="LiveId" clId="{89D755A0-B6BE-4298-A8F1-8524C25053C3}" dt="2024-04-15T09:22:22.620" v="22" actId="1076"/>
        <pc:sldMkLst>
          <pc:docMk/>
          <pc:sldMk cId="4101420613" sldId="257"/>
        </pc:sldMkLst>
        <pc:spChg chg="add mod">
          <ac:chgData name="Gordon Fuller" userId="12b4f67a74d88020" providerId="LiveId" clId="{89D755A0-B6BE-4298-A8F1-8524C25053C3}" dt="2024-04-15T09:22:21.564" v="21" actId="1076"/>
          <ac:spMkLst>
            <pc:docMk/>
            <pc:sldMk cId="4101420613" sldId="257"/>
            <ac:spMk id="14" creationId="{97759BFF-F6AE-3BC4-D8E2-1249AFD1BE3D}"/>
          </ac:spMkLst>
        </pc:spChg>
        <pc:picChg chg="add mod">
          <ac:chgData name="Gordon Fuller" userId="12b4f67a74d88020" providerId="LiveId" clId="{89D755A0-B6BE-4298-A8F1-8524C25053C3}" dt="2024-04-15T09:22:22.620" v="22" actId="1076"/>
          <ac:picMkLst>
            <pc:docMk/>
            <pc:sldMk cId="4101420613" sldId="257"/>
            <ac:picMk id="9" creationId="{6C409374-AF78-1CFC-52B2-72836AACE620}"/>
          </ac:picMkLst>
        </pc:picChg>
      </pc:sldChg>
      <pc:sldChg chg="addSp modSp new mod">
        <pc:chgData name="Gordon Fuller" userId="12b4f67a74d88020" providerId="LiveId" clId="{89D755A0-B6BE-4298-A8F1-8524C25053C3}" dt="2024-04-15T09:22:39.223" v="28" actId="1076"/>
        <pc:sldMkLst>
          <pc:docMk/>
          <pc:sldMk cId="742607875" sldId="258"/>
        </pc:sldMkLst>
        <pc:spChg chg="add mod">
          <ac:chgData name="Gordon Fuller" userId="12b4f67a74d88020" providerId="LiveId" clId="{89D755A0-B6BE-4298-A8F1-8524C25053C3}" dt="2024-04-15T09:22:38.248" v="27" actId="1076"/>
          <ac:spMkLst>
            <pc:docMk/>
            <pc:sldMk cId="742607875" sldId="258"/>
            <ac:spMk id="2" creationId="{CEDCC1D5-476D-F60A-BA4A-0D1E1262F6A1}"/>
          </ac:spMkLst>
        </pc:spChg>
        <pc:picChg chg="add mod">
          <ac:chgData name="Gordon Fuller" userId="12b4f67a74d88020" providerId="LiveId" clId="{89D755A0-B6BE-4298-A8F1-8524C25053C3}" dt="2024-04-15T09:22:39.223" v="28" actId="1076"/>
          <ac:picMkLst>
            <pc:docMk/>
            <pc:sldMk cId="742607875" sldId="258"/>
            <ac:picMk id="11" creationId="{C5F040CD-D587-1AFD-9BD0-73E6212DD56C}"/>
          </ac:picMkLst>
        </pc:picChg>
      </pc:sldChg>
      <pc:sldChg chg="addSp modSp new mod">
        <pc:chgData name="Gordon Fuller" userId="12b4f67a74d88020" providerId="LiveId" clId="{89D755A0-B6BE-4298-A8F1-8524C25053C3}" dt="2024-04-15T09:23:14.239" v="42" actId="1076"/>
        <pc:sldMkLst>
          <pc:docMk/>
          <pc:sldMk cId="1118571616" sldId="259"/>
        </pc:sldMkLst>
        <pc:spChg chg="add mod">
          <ac:chgData name="Gordon Fuller" userId="12b4f67a74d88020" providerId="LiveId" clId="{89D755A0-B6BE-4298-A8F1-8524C25053C3}" dt="2024-04-15T09:23:14.239" v="42" actId="1076"/>
          <ac:spMkLst>
            <pc:docMk/>
            <pc:sldMk cId="1118571616" sldId="259"/>
            <ac:spMk id="15" creationId="{D9D105C4-A43D-C449-30A9-1AAC6C95BB53}"/>
          </ac:spMkLst>
        </pc:spChg>
        <pc:picChg chg="add mod">
          <ac:chgData name="Gordon Fuller" userId="12b4f67a74d88020" providerId="LiveId" clId="{89D755A0-B6BE-4298-A8F1-8524C25053C3}" dt="2024-04-15T09:22:55.477" v="34" actId="1076"/>
          <ac:picMkLst>
            <pc:docMk/>
            <pc:sldMk cId="1118571616" sldId="259"/>
            <ac:picMk id="7" creationId="{3161FD39-83CD-8093-3C8C-54EB941F6834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A2A50F-598E-4CF2-9367-B434033742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8F1AD03-0F2A-12CE-646A-5C4B173937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1C32EE-A154-8669-D2BB-652FD85F32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132CA-D1B6-42E0-B6C9-DFB8BCD00F47}" type="datetimeFigureOut">
              <a:rPr lang="en-GB" smtClean="0"/>
              <a:t>15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D719DB-ECA4-1DD2-58B4-D1A15F804E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4D6506-004B-F6B8-4F8E-93C3B6A318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88551-8D3E-4270-8607-FEADB19B18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02696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37117F-C73D-0038-4247-6BFF4EA289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374D6D9-F546-50BB-2D52-B4BE6ECC26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0FFD69-026A-2FA0-3AD9-B512D20C4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132CA-D1B6-42E0-B6C9-DFB8BCD00F47}" type="datetimeFigureOut">
              <a:rPr lang="en-GB" smtClean="0"/>
              <a:t>15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280012-8D99-EE30-97DE-FB5AE5D896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102000-EFCB-01FA-531C-273C9703D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88551-8D3E-4270-8607-FEADB19B18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4480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6FD4AA3-4F70-B1CB-5438-8B15BA35A3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68D302-0E51-E6BF-98BA-95CC63FFA6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5E4ABE-7989-B867-FA98-D0F56E7AB4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132CA-D1B6-42E0-B6C9-DFB8BCD00F47}" type="datetimeFigureOut">
              <a:rPr lang="en-GB" smtClean="0"/>
              <a:t>15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B1F299-B915-73B8-C6A0-8782BE94F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AFB042-CADE-841B-D928-DEB3A8240C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88551-8D3E-4270-8607-FEADB19B18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3988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1D603C-2EFA-6B46-8F01-41CEDBD3C2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EAA93A-C039-106B-0C77-43DFA2C5054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50C8A4-0860-A831-9D74-DBC304F261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132CA-D1B6-42E0-B6C9-DFB8BCD00F47}" type="datetimeFigureOut">
              <a:rPr lang="en-GB" smtClean="0"/>
              <a:t>15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63F933-3E1F-BB8C-14D1-EBB7D23F7E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342FBC-B885-10F9-3404-9547D3178E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88551-8D3E-4270-8607-FEADB19B18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030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295F24-18CA-6E12-1B18-5183E2166D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C74297-D906-AEB4-3E23-1E39986059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470E72-5F69-A67B-F9B7-43E6790D62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132CA-D1B6-42E0-B6C9-DFB8BCD00F47}" type="datetimeFigureOut">
              <a:rPr lang="en-GB" smtClean="0"/>
              <a:t>15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823C33-6C09-8BE3-B61D-0040AA82C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82E48F-1327-7436-DA57-D4E0A1309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88551-8D3E-4270-8607-FEADB19B18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46444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614CDA-9181-DB9D-B1FD-2C75A8F597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5E8948-058D-EBE0-CEC0-D40F4CC9D0F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0B8BCB0-B5E2-3FD5-4235-0D310E9CF7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9B12B1-0D27-0FDE-B73B-7B252E4B36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132CA-D1B6-42E0-B6C9-DFB8BCD00F47}" type="datetimeFigureOut">
              <a:rPr lang="en-GB" smtClean="0"/>
              <a:t>15/04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3C4C7D-EF91-1D7F-90FF-705E8F374D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0A0196-B533-675F-E32D-C302512FEE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88551-8D3E-4270-8607-FEADB19B18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26803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3D6D3F-012B-0455-FF88-10F7E20153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610B76-B86D-FA8D-9347-C733BEC7E9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AA09FD3-7DDC-9B5A-83E3-0E5C301E1A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AB02346-E851-11CA-6796-E928FCCA66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3CECA29-A7DD-3373-5E64-7B7EB17D1C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49B0B73-1794-C12E-959E-556DB43E05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132CA-D1B6-42E0-B6C9-DFB8BCD00F47}" type="datetimeFigureOut">
              <a:rPr lang="en-GB" smtClean="0"/>
              <a:t>15/04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44DC9C1-786B-0EB3-F650-C50AA9AA3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435338A-8701-74DE-6BAA-B55ED1A334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88551-8D3E-4270-8607-FEADB19B18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012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760A6A-65A9-AE60-C2BC-9E9B80B2F4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8D4BB11-258E-FA40-3EE2-80C8909ADE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132CA-D1B6-42E0-B6C9-DFB8BCD00F47}" type="datetimeFigureOut">
              <a:rPr lang="en-GB" smtClean="0"/>
              <a:t>15/04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6D232E2-D38E-527D-C5BC-389412FD0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1CA089D-8F83-AE27-8BBE-EC126FCC71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88551-8D3E-4270-8607-FEADB19B18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4261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CF43B85-3E2B-A480-C1F9-543F64C7B9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132CA-D1B6-42E0-B6C9-DFB8BCD00F47}" type="datetimeFigureOut">
              <a:rPr lang="en-GB" smtClean="0"/>
              <a:t>15/04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3EED3D9-D219-9DF6-39A0-FDD06AFD49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8D14DAD-BDBE-7FAE-D21F-406B4271E2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88551-8D3E-4270-8607-FEADB19B18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9077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B9508C-55FC-1093-7891-5F87EA7237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C39AFC-C6F1-6A5C-F228-0B1A71B222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CCAF02-7C5B-DAEC-480E-1550937BCF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33275A-8224-385B-1E3C-C23FCCCE4A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132CA-D1B6-42E0-B6C9-DFB8BCD00F47}" type="datetimeFigureOut">
              <a:rPr lang="en-GB" smtClean="0"/>
              <a:t>15/04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91FA88-1559-BD0D-4615-37B028C1DD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4E53EF-069F-28D1-47DD-7356B778C5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88551-8D3E-4270-8607-FEADB19B18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6142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B78D51-A421-3DF9-2750-B57CBF3329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F300039-6422-0ED8-495A-5D850E16678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27141CE-4DE0-C959-F74B-C137031EC1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556698-D5A4-4FD2-6081-712D9DD8FD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132CA-D1B6-42E0-B6C9-DFB8BCD00F47}" type="datetimeFigureOut">
              <a:rPr lang="en-GB" smtClean="0"/>
              <a:t>15/04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EF8065-0DB3-26DD-41A3-C816BE303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6F7D78-03D3-1B32-2A38-72EFD2CC14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88551-8D3E-4270-8607-FEADB19B18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1951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3D561A8-662C-8942-6601-2B3B1CB422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4C1979-D6B0-5BA7-F021-B1F230E811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BCDD82-5A3F-265D-8BB7-B4A579368A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D132CA-D1B6-42E0-B6C9-DFB8BCD00F47}" type="datetimeFigureOut">
              <a:rPr lang="en-GB" smtClean="0"/>
              <a:t>15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DFB589-7F29-84D2-799F-1334F996FE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8D60DC-8963-CB56-356F-7E988F8CC94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C88551-8D3E-4270-8607-FEADB19B18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0340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flowchart&#10;&#10;Description automatically generated">
            <a:extLst>
              <a:ext uri="{FF2B5EF4-FFF2-40B4-BE49-F238E27FC236}">
                <a16:creationId xmlns:a16="http://schemas.microsoft.com/office/drawing/2014/main" id="{F3529407-8DA6-0AC9-A7E9-D5A80A835E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6052" y="576243"/>
            <a:ext cx="8376250" cy="6045283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6C1C3C1-A9EA-9213-D59B-E0156A601036}"/>
              </a:ext>
            </a:extLst>
          </p:cNvPr>
          <p:cNvSpPr txBox="1"/>
          <p:nvPr/>
        </p:nvSpPr>
        <p:spPr>
          <a:xfrm>
            <a:off x="4732101" y="268466"/>
            <a:ext cx="36386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/>
              <a:t>London Ambulance Service</a:t>
            </a:r>
          </a:p>
        </p:txBody>
      </p:sp>
    </p:spTree>
    <p:extLst>
      <p:ext uri="{BB962C8B-B14F-4D97-AF65-F5344CB8AC3E}">
        <p14:creationId xmlns:p14="http://schemas.microsoft.com/office/powerpoint/2010/main" val="16972413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diagram of a trauma triage tool&#10;&#10;Description automatically generated">
            <a:extLst>
              <a:ext uri="{FF2B5EF4-FFF2-40B4-BE49-F238E27FC236}">
                <a16:creationId xmlns:a16="http://schemas.microsoft.com/office/drawing/2014/main" id="{6C409374-AF78-1CFC-52B2-72836AACE62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4295" y="678828"/>
            <a:ext cx="8057071" cy="5697137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97759BFF-F6AE-3BC4-D8E2-1249AFD1BE3D}"/>
              </a:ext>
            </a:extLst>
          </p:cNvPr>
          <p:cNvSpPr txBox="1"/>
          <p:nvPr/>
        </p:nvSpPr>
        <p:spPr>
          <a:xfrm>
            <a:off x="3805522" y="96393"/>
            <a:ext cx="386266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/>
              <a:t>Yorkshire Ambulance Service</a:t>
            </a:r>
          </a:p>
        </p:txBody>
      </p:sp>
    </p:spTree>
    <p:extLst>
      <p:ext uri="{BB962C8B-B14F-4D97-AF65-F5344CB8AC3E}">
        <p14:creationId xmlns:p14="http://schemas.microsoft.com/office/powerpoint/2010/main" val="41014206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A diagram of a major trauma triage tool&#10;&#10;Description automatically generated">
            <a:extLst>
              <a:ext uri="{FF2B5EF4-FFF2-40B4-BE49-F238E27FC236}">
                <a16:creationId xmlns:a16="http://schemas.microsoft.com/office/drawing/2014/main" id="{C5F040CD-D587-1AFD-9BD0-73E6212DD5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2136" y="997366"/>
            <a:ext cx="6912634" cy="536847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EDCC1D5-476D-F60A-BA4A-0D1E1262F6A1}"/>
              </a:ext>
            </a:extLst>
          </p:cNvPr>
          <p:cNvSpPr txBox="1"/>
          <p:nvPr/>
        </p:nvSpPr>
        <p:spPr>
          <a:xfrm>
            <a:off x="3265804" y="279690"/>
            <a:ext cx="45940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/>
              <a:t>West Midlands Ambulance Service</a:t>
            </a:r>
          </a:p>
        </p:txBody>
      </p:sp>
    </p:spTree>
    <p:extLst>
      <p:ext uri="{BB962C8B-B14F-4D97-AF65-F5344CB8AC3E}">
        <p14:creationId xmlns:p14="http://schemas.microsoft.com/office/powerpoint/2010/main" val="7426078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diagram of a triangle&#10;&#10;Description automatically generated">
            <a:extLst>
              <a:ext uri="{FF2B5EF4-FFF2-40B4-BE49-F238E27FC236}">
                <a16:creationId xmlns:a16="http://schemas.microsoft.com/office/drawing/2014/main" id="{3161FD39-83CD-8093-3C8C-54EB941F68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83855" y="368292"/>
            <a:ext cx="4622332" cy="654578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D9D105C4-A43D-C449-30A9-1AAC6C95BB53}"/>
              </a:ext>
            </a:extLst>
          </p:cNvPr>
          <p:cNvSpPr txBox="1"/>
          <p:nvPr/>
        </p:nvSpPr>
        <p:spPr>
          <a:xfrm>
            <a:off x="414969" y="230269"/>
            <a:ext cx="46463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/>
              <a:t>South Western  Ambulance Service</a:t>
            </a:r>
          </a:p>
        </p:txBody>
      </p:sp>
    </p:spTree>
    <p:extLst>
      <p:ext uri="{BB962C8B-B14F-4D97-AF65-F5344CB8AC3E}">
        <p14:creationId xmlns:p14="http://schemas.microsoft.com/office/powerpoint/2010/main" val="11185716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4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rdon Fuller</dc:creator>
  <cp:lastModifiedBy>Gordon Fuller</cp:lastModifiedBy>
  <cp:revision>1</cp:revision>
  <dcterms:created xsi:type="dcterms:W3CDTF">2023-11-30T11:50:13Z</dcterms:created>
  <dcterms:modified xsi:type="dcterms:W3CDTF">2024-04-15T09:23:47Z</dcterms:modified>
</cp:coreProperties>
</file>